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F9D9324-6A84-46B6-8E7A-28A7295B81E2}" v="1" dt="2021-03-26T23:20:35.42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1" autoAdjust="0"/>
    <p:restoredTop sz="94660"/>
  </p:normalViewPr>
  <p:slideViewPr>
    <p:cSldViewPr snapToGrid="0">
      <p:cViewPr>
        <p:scale>
          <a:sx n="47" d="100"/>
          <a:sy n="47" d="100"/>
        </p:scale>
        <p:origin x="2616" y="5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rah Hill" userId="b774f213905f0ee8" providerId="LiveId" clId="{1F9D9324-6A84-46B6-8E7A-28A7295B81E2}"/>
    <pc:docChg chg="modSld">
      <pc:chgData name="Sarah Hill" userId="b774f213905f0ee8" providerId="LiveId" clId="{1F9D9324-6A84-46B6-8E7A-28A7295B81E2}" dt="2021-03-27T18:35:17.877" v="52" actId="20577"/>
      <pc:docMkLst>
        <pc:docMk/>
      </pc:docMkLst>
      <pc:sldChg chg="addSp modSp mod">
        <pc:chgData name="Sarah Hill" userId="b774f213905f0ee8" providerId="LiveId" clId="{1F9D9324-6A84-46B6-8E7A-28A7295B81E2}" dt="2021-03-27T18:35:17.877" v="52" actId="20577"/>
        <pc:sldMkLst>
          <pc:docMk/>
          <pc:sldMk cId="3319041387" sldId="256"/>
        </pc:sldMkLst>
        <pc:spChg chg="add mod">
          <ac:chgData name="Sarah Hill" userId="b774f213905f0ee8" providerId="LiveId" clId="{1F9D9324-6A84-46B6-8E7A-28A7295B81E2}" dt="2021-03-26T23:20:35.428" v="51"/>
          <ac:spMkLst>
            <pc:docMk/>
            <pc:sldMk cId="3319041387" sldId="256"/>
            <ac:spMk id="4" creationId="{75D12310-8A00-4B20-BB6F-9C89DA69D017}"/>
          </ac:spMkLst>
        </pc:spChg>
        <pc:spChg chg="mod">
          <ac:chgData name="Sarah Hill" userId="b774f213905f0ee8" providerId="LiveId" clId="{1F9D9324-6A84-46B6-8E7A-28A7295B81E2}" dt="2021-03-26T23:20:32.909" v="50" actId="1035"/>
          <ac:spMkLst>
            <pc:docMk/>
            <pc:sldMk cId="3319041387" sldId="256"/>
            <ac:spMk id="19" creationId="{6EF7B054-D577-4196-A487-71EABF40DE3B}"/>
          </ac:spMkLst>
        </pc:spChg>
        <pc:spChg chg="mod">
          <ac:chgData name="Sarah Hill" userId="b774f213905f0ee8" providerId="LiveId" clId="{1F9D9324-6A84-46B6-8E7A-28A7295B81E2}" dt="2021-03-27T18:35:17.877" v="52" actId="20577"/>
          <ac:spMkLst>
            <pc:docMk/>
            <pc:sldMk cId="3319041387" sldId="256"/>
            <ac:spMk id="20" creationId="{5A07ECB4-EE34-4AA8-94B0-27BA53D08A42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AB419-52A3-4BE6-8D5D-00AEBDEF7610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F82F0-D919-49F7-9A27-11E713B54A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66052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AB419-52A3-4BE6-8D5D-00AEBDEF7610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F82F0-D919-49F7-9A27-11E713B54A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4704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AB419-52A3-4BE6-8D5D-00AEBDEF7610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F82F0-D919-49F7-9A27-11E713B54A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8778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AB419-52A3-4BE6-8D5D-00AEBDEF7610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F82F0-D919-49F7-9A27-11E713B54A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437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AB419-52A3-4BE6-8D5D-00AEBDEF7610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F82F0-D919-49F7-9A27-11E713B54A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4548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AB419-52A3-4BE6-8D5D-00AEBDEF7610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F82F0-D919-49F7-9A27-11E713B54A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29538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AB419-52A3-4BE6-8D5D-00AEBDEF7610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F82F0-D919-49F7-9A27-11E713B54A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77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AB419-52A3-4BE6-8D5D-00AEBDEF7610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F82F0-D919-49F7-9A27-11E713B54A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62589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AB419-52A3-4BE6-8D5D-00AEBDEF7610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F82F0-D919-49F7-9A27-11E713B54A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77779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AB419-52A3-4BE6-8D5D-00AEBDEF7610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F82F0-D919-49F7-9A27-11E713B54A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68124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EAB419-52A3-4BE6-8D5D-00AEBDEF7610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CF82F0-D919-49F7-9A27-11E713B54A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8031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EAB419-52A3-4BE6-8D5D-00AEBDEF7610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CF82F0-D919-49F7-9A27-11E713B54A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685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Rectangle 18">
            <a:extLst>
              <a:ext uri="{FF2B5EF4-FFF2-40B4-BE49-F238E27FC236}">
                <a16:creationId xmlns:a16="http://schemas.microsoft.com/office/drawing/2014/main" id="{6EF7B054-D577-4196-A487-71EABF40DE3B}"/>
              </a:ext>
            </a:extLst>
          </p:cNvPr>
          <p:cNvSpPr/>
          <p:nvPr/>
        </p:nvSpPr>
        <p:spPr>
          <a:xfrm>
            <a:off x="1605883" y="2407741"/>
            <a:ext cx="3429000" cy="507831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Lane order for HEC1B </a:t>
            </a:r>
            <a:r>
              <a:rPr lang="en-US" dirty="0" err="1"/>
              <a:t>timecourse</a:t>
            </a:r>
            <a:r>
              <a:rPr lang="en-US" dirty="0"/>
              <a:t> in Figure 5F</a:t>
            </a:r>
          </a:p>
          <a:p>
            <a:endParaRPr lang="en-US" dirty="0"/>
          </a:p>
          <a:p>
            <a:r>
              <a:rPr lang="en-US" dirty="0"/>
              <a:t>14-Not this figure</a:t>
            </a:r>
          </a:p>
          <a:p>
            <a:r>
              <a:rPr lang="en-US" dirty="0"/>
              <a:t>13-Not this figure</a:t>
            </a:r>
          </a:p>
          <a:p>
            <a:r>
              <a:rPr lang="en-US" dirty="0"/>
              <a:t>12-Not this figure</a:t>
            </a:r>
          </a:p>
          <a:p>
            <a:r>
              <a:rPr lang="en-US" dirty="0"/>
              <a:t>11 Not this figure</a:t>
            </a:r>
          </a:p>
          <a:p>
            <a:r>
              <a:rPr lang="en-US" dirty="0"/>
              <a:t>10 HEC1B 24 </a:t>
            </a:r>
            <a:r>
              <a:rPr lang="en-US" dirty="0" err="1"/>
              <a:t>hr</a:t>
            </a:r>
            <a:r>
              <a:rPr lang="en-US" dirty="0"/>
              <a:t> 1775 + Alisertib</a:t>
            </a:r>
          </a:p>
          <a:p>
            <a:r>
              <a:rPr lang="en-US" dirty="0"/>
              <a:t>9 HEC1B 24hr Alisertib</a:t>
            </a:r>
          </a:p>
          <a:p>
            <a:r>
              <a:rPr lang="en-US" dirty="0"/>
              <a:t>8 HEC1B 24Hr 1775</a:t>
            </a:r>
          </a:p>
          <a:p>
            <a:r>
              <a:rPr lang="en-US" dirty="0"/>
              <a:t>7 HEC1B 8 </a:t>
            </a:r>
            <a:r>
              <a:rPr lang="en-US" dirty="0" err="1"/>
              <a:t>hr</a:t>
            </a:r>
            <a:r>
              <a:rPr lang="en-US" dirty="0"/>
              <a:t> 1775 + Alisertib</a:t>
            </a:r>
          </a:p>
          <a:p>
            <a:r>
              <a:rPr lang="en-US" dirty="0"/>
              <a:t>6 HEC1B 8hr Alisertib</a:t>
            </a:r>
          </a:p>
          <a:p>
            <a:r>
              <a:rPr lang="en-US" dirty="0"/>
              <a:t>5 HEC1B 8Hr 1775</a:t>
            </a:r>
          </a:p>
          <a:p>
            <a:r>
              <a:rPr lang="en-US" dirty="0"/>
              <a:t>4 HEC1B 3 </a:t>
            </a:r>
            <a:r>
              <a:rPr lang="en-US" dirty="0" err="1"/>
              <a:t>hr</a:t>
            </a:r>
            <a:r>
              <a:rPr lang="en-US" dirty="0"/>
              <a:t> 1775 + Alisertib</a:t>
            </a:r>
          </a:p>
          <a:p>
            <a:r>
              <a:rPr lang="en-US" dirty="0"/>
              <a:t>3 HEC1B 3hr Alisertib</a:t>
            </a:r>
          </a:p>
          <a:p>
            <a:r>
              <a:rPr lang="en-US" dirty="0"/>
              <a:t>2 HEC1B 3Hr 1775</a:t>
            </a:r>
          </a:p>
          <a:p>
            <a:r>
              <a:rPr lang="en-US" dirty="0"/>
              <a:t>1 HEC1B untreated</a:t>
            </a:r>
          </a:p>
          <a:p>
            <a:endParaRPr lang="en-US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A07ECB4-EE34-4AA8-94B0-27BA53D08A42}"/>
              </a:ext>
            </a:extLst>
          </p:cNvPr>
          <p:cNvSpPr txBox="1"/>
          <p:nvPr/>
        </p:nvSpPr>
        <p:spPr>
          <a:xfrm>
            <a:off x="733926" y="7975707"/>
            <a:ext cx="40546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an on blot #2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5D12310-8A00-4B20-BB6F-9C89DA69D017}"/>
              </a:ext>
            </a:extLst>
          </p:cNvPr>
          <p:cNvSpPr txBox="1"/>
          <p:nvPr/>
        </p:nvSpPr>
        <p:spPr>
          <a:xfrm>
            <a:off x="586154" y="339969"/>
            <a:ext cx="586153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or all blots specific to the figure, we have placed a box around the full western of interest and placed the lane numbers below. It.</a:t>
            </a:r>
          </a:p>
        </p:txBody>
      </p:sp>
    </p:spTree>
    <p:extLst>
      <p:ext uri="{BB962C8B-B14F-4D97-AF65-F5344CB8AC3E}">
        <p14:creationId xmlns:p14="http://schemas.microsoft.com/office/powerpoint/2010/main" val="33190413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iagram&#10;&#10;Description automatically generated">
            <a:extLst>
              <a:ext uri="{FF2B5EF4-FFF2-40B4-BE49-F238E27FC236}">
                <a16:creationId xmlns:a16="http://schemas.microsoft.com/office/drawing/2014/main" id="{21A55752-7D8A-4B47-9BB7-E01D6B28520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676466" y="820259"/>
            <a:ext cx="5505064" cy="6858002"/>
          </a:xfr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1CCF8656-E703-4401-ABD9-E54ADA5E724D}"/>
              </a:ext>
            </a:extLst>
          </p:cNvPr>
          <p:cNvSpPr/>
          <p:nvPr/>
        </p:nvSpPr>
        <p:spPr>
          <a:xfrm>
            <a:off x="542955" y="2663751"/>
            <a:ext cx="1791171" cy="68102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38576" tIns="19289" rIns="38576" bIns="19289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76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ABF2F5F4-1055-406C-99FB-61A6F3D06E12}"/>
              </a:ext>
            </a:extLst>
          </p:cNvPr>
          <p:cNvSpPr/>
          <p:nvPr/>
        </p:nvSpPr>
        <p:spPr>
          <a:xfrm>
            <a:off x="3927811" y="3912062"/>
            <a:ext cx="1787189" cy="438607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38576" tIns="19289" rIns="38576" bIns="19289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76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5576B03-9108-4981-B4EC-3A2CFA531EF1}"/>
              </a:ext>
            </a:extLst>
          </p:cNvPr>
          <p:cNvSpPr txBox="1"/>
          <p:nvPr/>
        </p:nvSpPr>
        <p:spPr>
          <a:xfrm>
            <a:off x="837286" y="3344779"/>
            <a:ext cx="14968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1 2  3  4  5  6  7  8 9 1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00A31CA-5F66-4295-ABCF-FDCCD9E83705}"/>
              </a:ext>
            </a:extLst>
          </p:cNvPr>
          <p:cNvSpPr txBox="1"/>
          <p:nvPr/>
        </p:nvSpPr>
        <p:spPr>
          <a:xfrm>
            <a:off x="4308376" y="4350669"/>
            <a:ext cx="14968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1 2  3  4  5  6  7  8 9 10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FBF239D-7DFA-4BF5-B993-DD33121C1E76}"/>
              </a:ext>
            </a:extLst>
          </p:cNvPr>
          <p:cNvSpPr txBox="1"/>
          <p:nvPr/>
        </p:nvSpPr>
        <p:spPr>
          <a:xfrm>
            <a:off x="1419726" y="517358"/>
            <a:ext cx="35733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EC1B Tubulin and cleaved </a:t>
            </a:r>
            <a:r>
              <a:rPr lang="en-US" dirty="0" err="1"/>
              <a:t>parp</a:t>
            </a:r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03FB91D-BA8B-43BD-9535-BFBA2DDDD078}"/>
              </a:ext>
            </a:extLst>
          </p:cNvPr>
          <p:cNvSpPr txBox="1"/>
          <p:nvPr/>
        </p:nvSpPr>
        <p:spPr>
          <a:xfrm>
            <a:off x="2574757" y="2899611"/>
            <a:ext cx="12151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ubulin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93B29AF-8FB4-49E5-AE84-E4A05CE35792}"/>
              </a:ext>
            </a:extLst>
          </p:cNvPr>
          <p:cNvSpPr txBox="1"/>
          <p:nvPr/>
        </p:nvSpPr>
        <p:spPr>
          <a:xfrm>
            <a:off x="4308376" y="3421723"/>
            <a:ext cx="19611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leaved </a:t>
            </a:r>
            <a:r>
              <a:rPr lang="en-US" dirty="0" err="1"/>
              <a:t>parp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202754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31</Words>
  <Application>Microsoft Office PowerPoint</Application>
  <PresentationFormat>Letter Paper (8.5x11 in)</PresentationFormat>
  <Paragraphs>2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ynch, Katherine N.</dc:creator>
  <cp:lastModifiedBy>Sarah Hill</cp:lastModifiedBy>
  <cp:revision>3</cp:revision>
  <dcterms:created xsi:type="dcterms:W3CDTF">2021-03-25T15:23:12Z</dcterms:created>
  <dcterms:modified xsi:type="dcterms:W3CDTF">2021-03-27T18:35:19Z</dcterms:modified>
</cp:coreProperties>
</file>